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5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6D04D8-7CCC-43FF-8565-610B4C9D6D11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009EA5-61D5-4362-8F75-179ED42EA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859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D87A7C-E4AF-461F-8F1B-475DDD688DC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D87A7C-E4AF-461F-8F1B-475DDD688DC5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2E66C-7FC5-4353-A1A6-12536EDCBE9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165E5-4B7D-4509-9C39-429C50D11E4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jpe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jpe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13" Type="http://schemas.openxmlformats.org/officeDocument/2006/relationships/image" Target="../media/image25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12" Type="http://schemas.openxmlformats.org/officeDocument/2006/relationships/image" Target="../media/image24.tif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5" Type="http://schemas.openxmlformats.org/officeDocument/2006/relationships/image" Target="../media/image2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tiff"/><Relationship Id="rId14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05000" y="95238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943600" y="97149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YT-1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vikramwali\Documents\Desktop\pc19\cyt1\C\cyt1 PC19d 595.tif"/>
          <p:cNvPicPr>
            <a:picLocks noChangeAspect="1" noChangeArrowheads="1"/>
          </p:cNvPicPr>
          <p:nvPr/>
        </p:nvPicPr>
        <p:blipFill>
          <a:blip r:embed="rId3" cstate="print"/>
          <a:srcRect l="10811" t="30769" r="10811" b="28205"/>
          <a:stretch>
            <a:fillRect/>
          </a:stretch>
        </p:blipFill>
        <p:spPr bwMode="auto">
          <a:xfrm>
            <a:off x="1676400" y="3276600"/>
            <a:ext cx="1892409" cy="74290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27" name="Picture 3" descr="C:\Users\vikramwali\Documents\Desktop\pc19\cyt1\C\cyt1 PC19d 515.tif"/>
          <p:cNvPicPr>
            <a:picLocks noChangeAspect="1" noChangeArrowheads="1"/>
          </p:cNvPicPr>
          <p:nvPr/>
        </p:nvPicPr>
        <p:blipFill>
          <a:blip r:embed="rId4" cstate="print"/>
          <a:srcRect t="25641" b="28205"/>
          <a:stretch>
            <a:fillRect/>
          </a:stretch>
        </p:blipFill>
        <p:spPr bwMode="auto">
          <a:xfrm>
            <a:off x="1676400" y="1371600"/>
            <a:ext cx="1981200" cy="6858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28" name="Picture 4" descr="C:\Users\vikramwali\Documents\Desktop\pc19\cyt1\C\cyt1 PC19d 548.tif"/>
          <p:cNvPicPr>
            <a:picLocks noChangeAspect="1" noChangeArrowheads="1"/>
          </p:cNvPicPr>
          <p:nvPr/>
        </p:nvPicPr>
        <p:blipFill>
          <a:blip r:embed="rId5" cstate="print"/>
          <a:srcRect t="20513" b="23077"/>
          <a:stretch>
            <a:fillRect/>
          </a:stretch>
        </p:blipFill>
        <p:spPr bwMode="auto">
          <a:xfrm>
            <a:off x="1676400" y="4267200"/>
            <a:ext cx="1828799" cy="77372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29" name="Picture 5" descr="C:\Users\vikramwali\Documents\Desktop\pc19\cyt1\C\cyt1 PC19d 569.tif"/>
          <p:cNvPicPr>
            <a:picLocks noChangeAspect="1" noChangeArrowheads="1"/>
          </p:cNvPicPr>
          <p:nvPr/>
        </p:nvPicPr>
        <p:blipFill>
          <a:blip r:embed="rId6" cstate="print"/>
          <a:srcRect t="15385" b="28205"/>
          <a:stretch>
            <a:fillRect/>
          </a:stretch>
        </p:blipFill>
        <p:spPr bwMode="auto">
          <a:xfrm>
            <a:off x="1676400" y="2209800"/>
            <a:ext cx="198120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1600200" y="4840124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4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600200" y="2814543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69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00200" y="1856601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15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600201" y="3810000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95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 descr="C:\Users\vikramwali\Documents\Desktop\pc19\cyt1\T\cyt1 PC19d 578.tif"/>
          <p:cNvPicPr>
            <a:picLocks noChangeAspect="1" noChangeArrowheads="1"/>
          </p:cNvPicPr>
          <p:nvPr/>
        </p:nvPicPr>
        <p:blipFill>
          <a:blip r:embed="rId7" cstate="print"/>
          <a:srcRect t="32576" b="25000"/>
          <a:stretch>
            <a:fillRect/>
          </a:stretch>
        </p:blipFill>
        <p:spPr bwMode="auto">
          <a:xfrm>
            <a:off x="4670896" y="5379989"/>
            <a:ext cx="1955454" cy="62219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31" name="Picture 7" descr="C:\Users\vikramwali\Documents\Desktop\pc19\cyt1\T\cyt1 PC19d 533.tif"/>
          <p:cNvPicPr>
            <a:picLocks noChangeAspect="1" noChangeArrowheads="1"/>
          </p:cNvPicPr>
          <p:nvPr/>
        </p:nvPicPr>
        <p:blipFill>
          <a:blip r:embed="rId8" cstate="print"/>
          <a:srcRect l="9091" t="26516" b="25000"/>
          <a:stretch>
            <a:fillRect/>
          </a:stretch>
        </p:blipFill>
        <p:spPr bwMode="auto">
          <a:xfrm>
            <a:off x="4662714" y="1447800"/>
            <a:ext cx="1777688" cy="7110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32" name="Picture 8" descr="C:\Users\vikramwali\Documents\Desktop\pc19\cyt1\T\cyt1 PC19d 551.tif"/>
          <p:cNvPicPr>
            <a:picLocks noChangeAspect="1" noChangeArrowheads="1"/>
          </p:cNvPicPr>
          <p:nvPr/>
        </p:nvPicPr>
        <p:blipFill>
          <a:blip r:embed="rId9" cstate="print"/>
          <a:srcRect l="18182" t="16667" b="25000"/>
          <a:stretch>
            <a:fillRect/>
          </a:stretch>
        </p:blipFill>
        <p:spPr bwMode="auto">
          <a:xfrm>
            <a:off x="4670895" y="3317868"/>
            <a:ext cx="1599919" cy="85551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33" name="Picture 9" descr="C:\Users\vikramwali\Documents\Desktop\pc19\cyt1\T\cyt1 PC19d 570.tif"/>
          <p:cNvPicPr>
            <a:picLocks noChangeAspect="1" noChangeArrowheads="1"/>
          </p:cNvPicPr>
          <p:nvPr/>
        </p:nvPicPr>
        <p:blipFill>
          <a:blip r:embed="rId10" cstate="print"/>
          <a:srcRect t="33333" b="16667"/>
          <a:stretch>
            <a:fillRect/>
          </a:stretch>
        </p:blipFill>
        <p:spPr bwMode="auto">
          <a:xfrm>
            <a:off x="4673944" y="4354483"/>
            <a:ext cx="1955456" cy="7332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34" name="Picture 10" descr="C:\Users\vikramwali\Documents\Desktop\pc19\cyt1\T\cyt1 PC19d 575.tif"/>
          <p:cNvPicPr>
            <a:picLocks noChangeAspect="1" noChangeArrowheads="1"/>
          </p:cNvPicPr>
          <p:nvPr/>
        </p:nvPicPr>
        <p:blipFill>
          <a:blip r:embed="rId11" cstate="print"/>
          <a:srcRect l="4545" t="25000" b="25000"/>
          <a:stretch>
            <a:fillRect/>
          </a:stretch>
        </p:blipFill>
        <p:spPr bwMode="auto">
          <a:xfrm>
            <a:off x="4670896" y="2420908"/>
            <a:ext cx="1866572" cy="7332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21" name="TextBox 20"/>
          <p:cNvSpPr txBox="1"/>
          <p:nvPr/>
        </p:nvSpPr>
        <p:spPr>
          <a:xfrm>
            <a:off x="4600792" y="485917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7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97744" y="2925604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75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83230" y="3972580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5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75048" y="1958076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3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97744" y="577357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7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667000" y="457200"/>
            <a:ext cx="4648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19 Days Post- Coitus (PC-19d)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6" descr="C:\Users\vikramwali\Documents\Desktop\Wysolmerski Lab WM pic\cyt1 291 19d pc.jpg"/>
          <p:cNvPicPr>
            <a:picLocks noChangeAspect="1" noChangeArrowheads="1"/>
          </p:cNvPicPr>
          <p:nvPr/>
        </p:nvPicPr>
        <p:blipFill>
          <a:blip r:embed="rId12" cstate="print"/>
          <a:srcRect l="28000" r="14000"/>
          <a:stretch>
            <a:fillRect/>
          </a:stretch>
        </p:blipFill>
        <p:spPr bwMode="auto">
          <a:xfrm rot="16200000">
            <a:off x="7474811" y="996163"/>
            <a:ext cx="744224" cy="171085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8" name="Picture 7" descr="C:\Users\vikramwali\Documents\Desktop\Wysolmerski Lab WM pic\cyt1 297 19d pc.jpg"/>
          <p:cNvPicPr>
            <a:picLocks noChangeAspect="1" noChangeArrowheads="1"/>
          </p:cNvPicPr>
          <p:nvPr/>
        </p:nvPicPr>
        <p:blipFill>
          <a:blip r:embed="rId13" cstate="print"/>
          <a:srcRect l="34667" r="13333"/>
          <a:stretch>
            <a:fillRect/>
          </a:stretch>
        </p:blipFill>
        <p:spPr bwMode="auto">
          <a:xfrm rot="16200000">
            <a:off x="7501909" y="2060892"/>
            <a:ext cx="639729" cy="16403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9" name="Picture 8" descr="C:\Users\vikramwali\Documents\Desktop\Wysolmerski Lab WM pic\cyt1298 19d pc.jpg"/>
          <p:cNvPicPr>
            <a:picLocks noChangeAspect="1" noChangeArrowheads="1"/>
          </p:cNvPicPr>
          <p:nvPr/>
        </p:nvPicPr>
        <p:blipFill>
          <a:blip r:embed="rId14" cstate="print"/>
          <a:srcRect l="32000" t="8000" r="22286" b="6500"/>
          <a:stretch>
            <a:fillRect/>
          </a:stretch>
        </p:blipFill>
        <p:spPr bwMode="auto">
          <a:xfrm rot="16200000">
            <a:off x="7486828" y="3005602"/>
            <a:ext cx="661935" cy="165070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6906687" y="3015865"/>
            <a:ext cx="442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9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912615" y="2024743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9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919874" y="394477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9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" name="Picture 4" descr="C:\Users\vikramwali\Documents\Desktop\Wysolmerski Lab WM pic\FVB 19d pc-1.jpg"/>
          <p:cNvPicPr>
            <a:picLocks noChangeAspect="1" noChangeArrowheads="1"/>
          </p:cNvPicPr>
          <p:nvPr/>
        </p:nvPicPr>
        <p:blipFill>
          <a:blip r:embed="rId15" cstate="print"/>
          <a:srcRect l="42667" r="6667"/>
          <a:stretch>
            <a:fillRect/>
          </a:stretch>
        </p:blipFill>
        <p:spPr bwMode="auto">
          <a:xfrm rot="16200000">
            <a:off x="2279469" y="4654731"/>
            <a:ext cx="622662" cy="16764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4" name="Picture 5" descr="C:\Users\vikramwali\Documents\Desktop\Wysolmerski Lab WM pic\FVB 19d pc-2.jpg"/>
          <p:cNvPicPr>
            <a:picLocks noChangeAspect="1" noChangeArrowheads="1"/>
          </p:cNvPicPr>
          <p:nvPr/>
        </p:nvPicPr>
        <p:blipFill>
          <a:blip r:embed="rId16" cstate="print"/>
          <a:srcRect l="33125" r="20000"/>
          <a:stretch>
            <a:fillRect/>
          </a:stretch>
        </p:blipFill>
        <p:spPr bwMode="auto">
          <a:xfrm rot="16200000">
            <a:off x="2257214" y="5457614"/>
            <a:ext cx="609600" cy="173397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35" name="TextBox 5"/>
          <p:cNvSpPr txBox="1"/>
          <p:nvPr/>
        </p:nvSpPr>
        <p:spPr>
          <a:xfrm>
            <a:off x="0" y="13901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5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71600" y="123807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10200" y="127629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YT-2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4" name="Picture 6" descr="C:\Users\vikramwali\Documents\Desktop\pc19\cyt2\C\cyt2 PC19d 324-jd.tif"/>
          <p:cNvPicPr>
            <a:picLocks noChangeAspect="1" noChangeArrowheads="1"/>
          </p:cNvPicPr>
          <p:nvPr/>
        </p:nvPicPr>
        <p:blipFill>
          <a:blip r:embed="rId3" cstate="print"/>
          <a:srcRect t="23529" b="29412"/>
          <a:stretch>
            <a:fillRect/>
          </a:stretch>
        </p:blipFill>
        <p:spPr bwMode="auto">
          <a:xfrm>
            <a:off x="1219200" y="5257800"/>
            <a:ext cx="1676400" cy="59167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55" name="Picture 7" descr="C:\Users\vikramwali\Documents\Desktop\pc19\cyt2\C\cyt2 PC19d 283.tif"/>
          <p:cNvPicPr>
            <a:picLocks noChangeAspect="1" noChangeArrowheads="1"/>
          </p:cNvPicPr>
          <p:nvPr/>
        </p:nvPicPr>
        <p:blipFill>
          <a:blip r:embed="rId4" cstate="print"/>
          <a:srcRect t="15686" b="29412"/>
          <a:stretch>
            <a:fillRect/>
          </a:stretch>
        </p:blipFill>
        <p:spPr bwMode="auto">
          <a:xfrm>
            <a:off x="1216152" y="2710627"/>
            <a:ext cx="1676401" cy="69028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56" name="Picture 8" descr="C:\Users\vikramwali\Documents\Desktop\pc19\cyt2\C\cyt2 PC19d 314.tif"/>
          <p:cNvPicPr>
            <a:picLocks noChangeAspect="1" noChangeArrowheads="1"/>
          </p:cNvPicPr>
          <p:nvPr/>
        </p:nvPicPr>
        <p:blipFill>
          <a:blip r:embed="rId5" cstate="print"/>
          <a:srcRect l="11765" t="29229" b="21569"/>
          <a:stretch>
            <a:fillRect/>
          </a:stretch>
        </p:blipFill>
        <p:spPr bwMode="auto">
          <a:xfrm>
            <a:off x="1216152" y="1872427"/>
            <a:ext cx="1572667" cy="65771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57" name="Picture 9" descr="C:\Users\vikramwali\Documents\Desktop\pc19\cyt2\C\cyt2 PC19d 317.tif"/>
          <p:cNvPicPr>
            <a:picLocks noChangeAspect="1" noChangeArrowheads="1"/>
          </p:cNvPicPr>
          <p:nvPr/>
        </p:nvPicPr>
        <p:blipFill>
          <a:blip r:embed="rId6" cstate="print"/>
          <a:srcRect l="11765" t="23529" b="21569"/>
          <a:stretch>
            <a:fillRect/>
          </a:stretch>
        </p:blipFill>
        <p:spPr bwMode="auto">
          <a:xfrm>
            <a:off x="1216152" y="3581400"/>
            <a:ext cx="1572667" cy="73391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58" name="Picture 10" descr="C:\Users\vikramwali\Documents\Desktop\pc19\cyt2\C\cyt2 PC19d 318-jd.tif"/>
          <p:cNvPicPr>
            <a:picLocks noChangeAspect="1" noChangeArrowheads="1"/>
          </p:cNvPicPr>
          <p:nvPr/>
        </p:nvPicPr>
        <p:blipFill>
          <a:blip r:embed="rId7" cstate="print"/>
          <a:srcRect t="23529" r="4546" b="29412"/>
          <a:stretch>
            <a:fillRect/>
          </a:stretch>
        </p:blipFill>
        <p:spPr bwMode="auto">
          <a:xfrm>
            <a:off x="1216152" y="4495800"/>
            <a:ext cx="1600199" cy="59167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1143000" y="4864856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1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146048" y="562117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24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143000" y="409717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1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43000" y="2312006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14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43000" y="318277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8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9" name="Picture 11" descr="C:\Users\vikramwali\Documents\Desktop\pc19\cyt2\T\cyt2 PC19d 336.tif"/>
          <p:cNvPicPr>
            <a:picLocks noChangeAspect="1" noChangeArrowheads="1"/>
          </p:cNvPicPr>
          <p:nvPr/>
        </p:nvPicPr>
        <p:blipFill>
          <a:blip r:embed="rId8" cstate="print"/>
          <a:srcRect t="20513" b="28205"/>
          <a:stretch>
            <a:fillRect/>
          </a:stretch>
        </p:blipFill>
        <p:spPr bwMode="auto">
          <a:xfrm>
            <a:off x="6781800" y="2971799"/>
            <a:ext cx="1447801" cy="55684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0" name="Picture 12" descr="C:\Users\vikramwali\Documents\Desktop\pc19\cyt2\T\cyt2 PC19d 281.tif"/>
          <p:cNvPicPr>
            <a:picLocks noChangeAspect="1" noChangeArrowheads="1"/>
          </p:cNvPicPr>
          <p:nvPr/>
        </p:nvPicPr>
        <p:blipFill>
          <a:blip r:embed="rId9" cstate="print"/>
          <a:srcRect t="20513" b="28205"/>
          <a:stretch>
            <a:fillRect/>
          </a:stretch>
        </p:blipFill>
        <p:spPr bwMode="auto">
          <a:xfrm>
            <a:off x="4343400" y="4692654"/>
            <a:ext cx="1447800" cy="55684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1" name="Picture 13" descr="C:\Users\vikramwali\Documents\Desktop\pc19\cyt2\T\cyt2 PC19d 282.tif"/>
          <p:cNvPicPr>
            <a:picLocks noChangeAspect="1" noChangeArrowheads="1"/>
          </p:cNvPicPr>
          <p:nvPr/>
        </p:nvPicPr>
        <p:blipFill>
          <a:blip r:embed="rId10" cstate="print"/>
          <a:srcRect l="15385" t="20513" r="7692" b="38461"/>
          <a:stretch>
            <a:fillRect/>
          </a:stretch>
        </p:blipFill>
        <p:spPr bwMode="auto">
          <a:xfrm>
            <a:off x="6781800" y="1981200"/>
            <a:ext cx="1356527" cy="54261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2" name="Picture 14" descr="C:\Users\vikramwali\Documents\Desktop\pc19\cyt2\T\cyt2 PC19d 285.tif"/>
          <p:cNvPicPr>
            <a:picLocks noChangeAspect="1" noChangeArrowheads="1"/>
          </p:cNvPicPr>
          <p:nvPr/>
        </p:nvPicPr>
        <p:blipFill>
          <a:blip r:embed="rId11" cstate="print"/>
          <a:srcRect t="20513" b="17949"/>
          <a:stretch>
            <a:fillRect/>
          </a:stretch>
        </p:blipFill>
        <p:spPr bwMode="auto">
          <a:xfrm>
            <a:off x="4346448" y="5530854"/>
            <a:ext cx="1371600" cy="63304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3" name="Picture 15" descr="C:\Users\vikramwali\Documents\Desktop\pc19\cyt2\T\cyt2 PC19d 289.tif"/>
          <p:cNvPicPr>
            <a:picLocks noChangeAspect="1" noChangeArrowheads="1"/>
          </p:cNvPicPr>
          <p:nvPr/>
        </p:nvPicPr>
        <p:blipFill>
          <a:blip r:embed="rId12" cstate="print"/>
          <a:srcRect t="20513" b="28205"/>
          <a:stretch>
            <a:fillRect/>
          </a:stretch>
        </p:blipFill>
        <p:spPr bwMode="auto">
          <a:xfrm rot="10800000">
            <a:off x="4422648" y="1919514"/>
            <a:ext cx="1584959" cy="609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4" name="Picture 16" descr="C:\Users\vikramwali\Documents\Desktop\pc19\cyt2\T\cyt2 PC19d 310.tif"/>
          <p:cNvPicPr>
            <a:picLocks noChangeAspect="1" noChangeArrowheads="1"/>
          </p:cNvPicPr>
          <p:nvPr/>
        </p:nvPicPr>
        <p:blipFill>
          <a:blip r:embed="rId13" cstate="print"/>
          <a:srcRect t="30769" b="17949"/>
          <a:stretch>
            <a:fillRect/>
          </a:stretch>
        </p:blipFill>
        <p:spPr bwMode="auto">
          <a:xfrm>
            <a:off x="4346447" y="3886200"/>
            <a:ext cx="1524000" cy="5861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5" name="Picture 17" descr="C:\Users\vikramwali\Documents\Desktop\pc19\cyt2\T\cyt2 PC19d 315.tif"/>
          <p:cNvPicPr>
            <a:picLocks noChangeAspect="1" noChangeArrowheads="1"/>
          </p:cNvPicPr>
          <p:nvPr/>
        </p:nvPicPr>
        <p:blipFill>
          <a:blip r:embed="rId14" cstate="print"/>
          <a:srcRect t="30769" b="17949"/>
          <a:stretch>
            <a:fillRect/>
          </a:stretch>
        </p:blipFill>
        <p:spPr bwMode="auto">
          <a:xfrm>
            <a:off x="4371703" y="2971800"/>
            <a:ext cx="1571897" cy="6045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6" name="Picture 18" descr="C:\Users\vikramwali\Documents\Desktop\pc19\cyt2\T\cyt2 PC19d 332.tif"/>
          <p:cNvPicPr>
            <a:picLocks noChangeAspect="1" noChangeArrowheads="1"/>
          </p:cNvPicPr>
          <p:nvPr/>
        </p:nvPicPr>
        <p:blipFill>
          <a:blip r:embed="rId15" cstate="print"/>
          <a:srcRect l="7692" t="20513" b="28205"/>
          <a:stretch>
            <a:fillRect/>
          </a:stretch>
        </p:blipFill>
        <p:spPr bwMode="auto">
          <a:xfrm>
            <a:off x="6705600" y="4648200"/>
            <a:ext cx="1676400" cy="6985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2067" name="Picture 19" descr="C:\Users\vikramwali\Documents\Desktop\pc19\cyt2\T\cyt2 PC19d 334.tif"/>
          <p:cNvPicPr>
            <a:picLocks noChangeAspect="1" noChangeArrowheads="1"/>
          </p:cNvPicPr>
          <p:nvPr/>
        </p:nvPicPr>
        <p:blipFill>
          <a:blip r:embed="rId16" cstate="print"/>
          <a:srcRect l="7692" t="20513" b="22683"/>
          <a:stretch>
            <a:fillRect/>
          </a:stretch>
        </p:blipFill>
        <p:spPr bwMode="auto">
          <a:xfrm>
            <a:off x="6705600" y="3657600"/>
            <a:ext cx="1371600" cy="61722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6702552" y="2329542"/>
            <a:ext cx="542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82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67200" y="5955044"/>
            <a:ext cx="904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85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702552" y="3334304"/>
            <a:ext cx="6330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36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264153" y="5059140"/>
            <a:ext cx="6330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81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629400" y="5134837"/>
            <a:ext cx="865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32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629400" y="4085772"/>
            <a:ext cx="904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34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295503" y="3381828"/>
            <a:ext cx="6330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15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284761" y="4278644"/>
            <a:ext cx="6330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31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363217" y="2329190"/>
            <a:ext cx="542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289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057400" y="285690"/>
            <a:ext cx="4648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19 Days Post- Coitus (PC-19d)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9</Words>
  <Application>Microsoft Office PowerPoint</Application>
  <PresentationFormat>On-screen Show (4:3)</PresentationFormat>
  <Paragraphs>35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kramwali</dc:creator>
  <cp:lastModifiedBy>Wali, Vikram</cp:lastModifiedBy>
  <cp:revision>2</cp:revision>
  <dcterms:created xsi:type="dcterms:W3CDTF">2013-05-24T16:26:59Z</dcterms:created>
  <dcterms:modified xsi:type="dcterms:W3CDTF">2014-06-13T03:44:45Z</dcterms:modified>
</cp:coreProperties>
</file>